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96" r:id="rId2"/>
  </p:sldIdLst>
  <p:sldSz cx="9144000" cy="6858000" type="screen4x3"/>
  <p:notesSz cx="6858000" cy="9313863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60A060"/>
    <a:srgbClr val="CC0000"/>
    <a:srgbClr val="9E7800"/>
    <a:srgbClr val="DAA600"/>
    <a:srgbClr val="CC9900"/>
    <a:srgbClr val="FFFF66"/>
    <a:srgbClr val="FF3300"/>
    <a:srgbClr val="FF7C80"/>
    <a:srgbClr val="684F00"/>
    <a:srgbClr val="5559A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8EC20E35-A176-4012-BC5E-935CFFF8708E}" styleName="Medium Style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vertBarState="maximized">
    <p:restoredLeft sz="15620" autoAdjust="0"/>
    <p:restoredTop sz="94629" autoAdjust="0"/>
  </p:normalViewPr>
  <p:slideViewPr>
    <p:cSldViewPr>
      <p:cViewPr>
        <p:scale>
          <a:sx n="120" d="100"/>
          <a:sy n="120" d="100"/>
        </p:scale>
        <p:origin x="498" y="90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\\hijum\docs\ewa\CHolestasis%20paper\rebuttal%20cholestasis%20papaer\Copy%20of%20ATP%20Chlorprom%20+%20eth%20estra%20csa%20pilot.xls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\\hijum\docs\ewa\CHolestasis%20paper\rebuttal%20cholestasis%20papaer\Copy%20of%20ATP%20Chlorprom%20+%20eth%20estra%20csa%20pilot.xls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\\hijum\docs\ewa\CHolestasis%20paper\rebuttal%20cholestasis%20papaer\Copy%20of%20ATP%20Chlorprom%20+%20eth%20estra%20csa%20pilot.xls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\\hijum\docs\ewa\CHolestasis%20paper\rebuttal%20cholestasis%20papaer\necrosis\Copy%20of%20ATP%2005092012%20necrosis%20for%20paper%20200-1.xls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\\hijum\docs\ewa\CHolestasis%20paper\rebuttal%20cholestasis%20papaer\necrosis\Copy%20of%20ATP%2005092012%20necrosis%20for%20paper%20200-1.xls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\\hijum\docs\ewa\CHolestasis%20paper\rebuttal%20cholestasis%20papaer\necrosis\Copy%20of%20ATP%2005092012%20necrosis%20for%20paper%20200-1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/>
          <a:lstStyle/>
          <a:p>
            <a:pPr>
              <a:defRPr b="0"/>
            </a:pPr>
            <a:r>
              <a:rPr lang="en-US" b="0"/>
              <a:t>ATP content</a:t>
            </a:r>
          </a:p>
        </c:rich>
      </c:tx>
      <c:layout/>
      <c:overlay val="1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v>we</c:v>
          </c:tx>
          <c:invertIfNegative val="0"/>
          <c:errBars>
            <c:errBarType val="both"/>
            <c:errValType val="cust"/>
            <c:noEndCap val="0"/>
            <c:plus>
              <c:numRef>
                <c:f>Sheet1!$W$123:$W$127</c:f>
                <c:numCache>
                  <c:formatCode>General</c:formatCode>
                  <c:ptCount val="5"/>
                  <c:pt idx="0">
                    <c:v>0.18238363612628125</c:v>
                  </c:pt>
                  <c:pt idx="1">
                    <c:v>1.3262494787934906</c:v>
                  </c:pt>
                  <c:pt idx="2">
                    <c:v>1.1073292193381339</c:v>
                  </c:pt>
                  <c:pt idx="3">
                    <c:v>2.1439179876405068</c:v>
                  </c:pt>
                  <c:pt idx="4">
                    <c:v>0.28065068145294148</c:v>
                  </c:pt>
                </c:numCache>
              </c:numRef>
            </c:plus>
            <c:minus>
              <c:numRef>
                <c:f>Sheet1!$W$123:$W$127</c:f>
                <c:numCache>
                  <c:formatCode>General</c:formatCode>
                  <c:ptCount val="5"/>
                  <c:pt idx="0">
                    <c:v>0.18238363612628125</c:v>
                  </c:pt>
                  <c:pt idx="1">
                    <c:v>1.3262494787934906</c:v>
                  </c:pt>
                  <c:pt idx="2">
                    <c:v>1.1073292193381339</c:v>
                  </c:pt>
                  <c:pt idx="3">
                    <c:v>2.1439179876405068</c:v>
                  </c:pt>
                  <c:pt idx="4">
                    <c:v>0.28065068145294148</c:v>
                  </c:pt>
                </c:numCache>
              </c:numRef>
            </c:minus>
          </c:errBars>
          <c:cat>
            <c:strRef>
              <c:f>Sheet1!$S$123:$S$127</c:f>
              <c:strCache>
                <c:ptCount val="5"/>
                <c:pt idx="0">
                  <c:v>control</c:v>
                </c:pt>
                <c:pt idx="1">
                  <c:v>1</c:v>
                </c:pt>
                <c:pt idx="2">
                  <c:v>2</c:v>
                </c:pt>
                <c:pt idx="3">
                  <c:v>40</c:v>
                </c:pt>
                <c:pt idx="4">
                  <c:v>100</c:v>
                </c:pt>
              </c:strCache>
            </c:strRef>
          </c:cat>
          <c:val>
            <c:numRef>
              <c:f>Sheet1!$V$123:$V$127</c:f>
              <c:numCache>
                <c:formatCode>General</c:formatCode>
                <c:ptCount val="5"/>
                <c:pt idx="0">
                  <c:v>7.657835294117648</c:v>
                </c:pt>
                <c:pt idx="1">
                  <c:v>6.640200000000001</c:v>
                </c:pt>
                <c:pt idx="2">
                  <c:v>6.2262000000000013</c:v>
                </c:pt>
                <c:pt idx="3">
                  <c:v>7.8902526315789485</c:v>
                </c:pt>
                <c:pt idx="4">
                  <c:v>6.552630000000000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379264"/>
        <c:axId val="35160640"/>
      </c:barChart>
      <c:catAx>
        <c:axId val="2379264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b="0"/>
                </a:pPr>
                <a:r>
                  <a:rPr lang="en-US" b="0"/>
                  <a:t>CsA concentration (</a:t>
                </a:r>
                <a:r>
                  <a:rPr lang="en-US" b="0">
                    <a:latin typeface="Times New Roman"/>
                    <a:cs typeface="Times New Roman"/>
                  </a:rPr>
                  <a:t>µ</a:t>
                </a:r>
                <a:r>
                  <a:rPr lang="en-US" b="0"/>
                  <a:t>M)</a:t>
                </a:r>
              </a:p>
            </c:rich>
          </c:tx>
          <c:layout/>
          <c:overlay val="0"/>
        </c:title>
        <c:majorTickMark val="out"/>
        <c:minorTickMark val="none"/>
        <c:tickLblPos val="nextTo"/>
        <c:crossAx val="35160640"/>
        <c:crosses val="autoZero"/>
        <c:auto val="1"/>
        <c:lblAlgn val="ctr"/>
        <c:lblOffset val="100"/>
        <c:noMultiLvlLbl val="0"/>
      </c:catAx>
      <c:valAx>
        <c:axId val="35160640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b="0"/>
                </a:pPr>
                <a:r>
                  <a:rPr lang="en-US" b="0"/>
                  <a:t>ATP nmol/mg protein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2379264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/>
          <a:lstStyle/>
          <a:p>
            <a:pPr>
              <a:defRPr b="0"/>
            </a:pPr>
            <a:r>
              <a:rPr lang="en-US" b="0"/>
              <a:t>ATP content</a:t>
            </a:r>
          </a:p>
        </c:rich>
      </c:tx>
      <c:layout/>
      <c:overlay val="0"/>
    </c:title>
    <c:autoTitleDeleted val="0"/>
    <c:plotArea>
      <c:layout>
        <c:manualLayout>
          <c:layoutTarget val="inner"/>
          <c:xMode val="edge"/>
          <c:yMode val="edge"/>
          <c:x val="0.18263901605322591"/>
          <c:y val="0.10760451818522683"/>
          <c:w val="0.77472532503204539"/>
          <c:h val="0.61705802399700038"/>
        </c:manualLayout>
      </c:layout>
      <c:barChart>
        <c:barDir val="col"/>
        <c:grouping val="clustered"/>
        <c:varyColors val="0"/>
        <c:ser>
          <c:idx val="0"/>
          <c:order val="0"/>
          <c:tx>
            <c:v>ss</c:v>
          </c:tx>
          <c:invertIfNegative val="0"/>
          <c:errBars>
            <c:errBarType val="both"/>
            <c:errValType val="cust"/>
            <c:noEndCap val="0"/>
            <c:plus>
              <c:numRef>
                <c:f>Sheet1!$W$135:$W$139</c:f>
                <c:numCache>
                  <c:formatCode>General</c:formatCode>
                  <c:ptCount val="5"/>
                  <c:pt idx="0">
                    <c:v>0.2797907990356362</c:v>
                  </c:pt>
                  <c:pt idx="1">
                    <c:v>0.53632281586046593</c:v>
                  </c:pt>
                  <c:pt idx="2">
                    <c:v>1.2836427596930846</c:v>
                  </c:pt>
                  <c:pt idx="3">
                    <c:v>2.0019748610309747</c:v>
                  </c:pt>
                  <c:pt idx="4">
                    <c:v>3.7825793376097989E-2</c:v>
                  </c:pt>
                </c:numCache>
              </c:numRef>
            </c:plus>
            <c:minus>
              <c:numRef>
                <c:f>Sheet1!$W$135:$W$139</c:f>
                <c:numCache>
                  <c:formatCode>General</c:formatCode>
                  <c:ptCount val="5"/>
                  <c:pt idx="0">
                    <c:v>0.2797907990356362</c:v>
                  </c:pt>
                  <c:pt idx="1">
                    <c:v>0.53632281586046593</c:v>
                  </c:pt>
                  <c:pt idx="2">
                    <c:v>1.2836427596930846</c:v>
                  </c:pt>
                  <c:pt idx="3">
                    <c:v>2.0019748610309747</c:v>
                  </c:pt>
                  <c:pt idx="4">
                    <c:v>3.7825793376097989E-2</c:v>
                  </c:pt>
                </c:numCache>
              </c:numRef>
            </c:minus>
          </c:errBars>
          <c:cat>
            <c:strRef>
              <c:f>Sheet1!$S$135:$S$139</c:f>
              <c:strCache>
                <c:ptCount val="5"/>
                <c:pt idx="0">
                  <c:v>control</c:v>
                </c:pt>
                <c:pt idx="1">
                  <c:v>2</c:v>
                </c:pt>
                <c:pt idx="2">
                  <c:v>4</c:v>
                </c:pt>
                <c:pt idx="3">
                  <c:v>20</c:v>
                </c:pt>
                <c:pt idx="4">
                  <c:v>80</c:v>
                </c:pt>
              </c:strCache>
            </c:strRef>
          </c:cat>
          <c:val>
            <c:numRef>
              <c:f>Sheet1!$V$135:$V$139</c:f>
              <c:numCache>
                <c:formatCode>General</c:formatCode>
                <c:ptCount val="5"/>
                <c:pt idx="0">
                  <c:v>8.1418575000000004</c:v>
                </c:pt>
                <c:pt idx="1">
                  <c:v>6.8099625000000001</c:v>
                </c:pt>
                <c:pt idx="2">
                  <c:v>8.406247500000001</c:v>
                </c:pt>
                <c:pt idx="3">
                  <c:v>9.3800700000000017</c:v>
                </c:pt>
                <c:pt idx="4">
                  <c:v>1.261153125000000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412544"/>
        <c:axId val="35162368"/>
      </c:barChart>
      <c:catAx>
        <c:axId val="2412544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b="0"/>
                </a:pPr>
                <a:r>
                  <a:rPr lang="en-US" b="0"/>
                  <a:t>CPZ concentration (</a:t>
                </a:r>
                <a:r>
                  <a:rPr lang="en-US" b="0">
                    <a:latin typeface="Times New Roman"/>
                    <a:cs typeface="Times New Roman"/>
                  </a:rPr>
                  <a:t>µ</a:t>
                </a:r>
                <a:r>
                  <a:rPr lang="en-US" b="0"/>
                  <a:t>M)</a:t>
                </a:r>
              </a:p>
            </c:rich>
          </c:tx>
          <c:layout/>
          <c:overlay val="0"/>
        </c:title>
        <c:majorTickMark val="out"/>
        <c:minorTickMark val="none"/>
        <c:tickLblPos val="nextTo"/>
        <c:crossAx val="35162368"/>
        <c:crosses val="autoZero"/>
        <c:auto val="1"/>
        <c:lblAlgn val="ctr"/>
        <c:lblOffset val="100"/>
        <c:noMultiLvlLbl val="0"/>
      </c:catAx>
      <c:valAx>
        <c:axId val="35162368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b="0"/>
                </a:pPr>
                <a:r>
                  <a:rPr lang="en-US" b="0"/>
                  <a:t>ATP nmol/mg of protein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2412544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/>
          <a:lstStyle/>
          <a:p>
            <a:pPr>
              <a:defRPr b="0"/>
            </a:pPr>
            <a:r>
              <a:rPr lang="en-US" b="0"/>
              <a:t>ATP content</a:t>
            </a:r>
          </a:p>
        </c:rich>
      </c:tx>
      <c:layout/>
      <c:overlay val="0"/>
    </c:title>
    <c:autoTitleDeleted val="0"/>
    <c:plotArea>
      <c:layout>
        <c:manualLayout>
          <c:layoutTarget val="inner"/>
          <c:xMode val="edge"/>
          <c:yMode val="edge"/>
          <c:x val="0.18263901605322591"/>
          <c:y val="0.14331880389951254"/>
          <c:w val="0.77472532503204539"/>
          <c:h val="0.58134373828271479"/>
        </c:manualLayout>
      </c:layout>
      <c:barChart>
        <c:barDir val="col"/>
        <c:grouping val="clustered"/>
        <c:varyColors val="0"/>
        <c:ser>
          <c:idx val="0"/>
          <c:order val="0"/>
          <c:tx>
            <c:v>ss</c:v>
          </c:tx>
          <c:invertIfNegative val="0"/>
          <c:errBars>
            <c:errBarType val="both"/>
            <c:errValType val="cust"/>
            <c:noEndCap val="0"/>
            <c:plus>
              <c:numRef>
                <c:f>Sheet1!$W$144:$W$148</c:f>
                <c:numCache>
                  <c:formatCode>General</c:formatCode>
                  <c:ptCount val="5"/>
                  <c:pt idx="0">
                    <c:v>1.1710581977863666</c:v>
                  </c:pt>
                  <c:pt idx="1">
                    <c:v>0.91221254580001332</c:v>
                  </c:pt>
                  <c:pt idx="2">
                    <c:v>0.47947299044743918</c:v>
                  </c:pt>
                  <c:pt idx="3">
                    <c:v>0.57042756378686199</c:v>
                  </c:pt>
                  <c:pt idx="4">
                    <c:v>0.53370183575224062</c:v>
                  </c:pt>
                </c:numCache>
              </c:numRef>
            </c:plus>
            <c:minus>
              <c:numRef>
                <c:f>Sheet1!$W$144:$W$148</c:f>
                <c:numCache>
                  <c:formatCode>General</c:formatCode>
                  <c:ptCount val="5"/>
                  <c:pt idx="0">
                    <c:v>1.1710581977863666</c:v>
                  </c:pt>
                  <c:pt idx="1">
                    <c:v>0.91221254580001332</c:v>
                  </c:pt>
                  <c:pt idx="2">
                    <c:v>0.47947299044743918</c:v>
                  </c:pt>
                  <c:pt idx="3">
                    <c:v>0.57042756378686199</c:v>
                  </c:pt>
                  <c:pt idx="4">
                    <c:v>0.53370183575224062</c:v>
                  </c:pt>
                </c:numCache>
              </c:numRef>
            </c:minus>
          </c:errBars>
          <c:cat>
            <c:strRef>
              <c:f>Sheet1!$S$144:$S$148</c:f>
              <c:strCache>
                <c:ptCount val="5"/>
                <c:pt idx="0">
                  <c:v>control</c:v>
                </c:pt>
                <c:pt idx="1">
                  <c:v>0.1</c:v>
                </c:pt>
                <c:pt idx="2">
                  <c:v>1</c:v>
                </c:pt>
                <c:pt idx="3">
                  <c:v>10</c:v>
                </c:pt>
                <c:pt idx="4">
                  <c:v>100</c:v>
                </c:pt>
              </c:strCache>
            </c:strRef>
          </c:cat>
          <c:val>
            <c:numRef>
              <c:f>Sheet1!$V$144:$V$148</c:f>
              <c:numCache>
                <c:formatCode>General</c:formatCode>
                <c:ptCount val="5"/>
                <c:pt idx="0">
                  <c:v>7.7657944480042014</c:v>
                </c:pt>
                <c:pt idx="1">
                  <c:v>9.7016258571428562</c:v>
                </c:pt>
                <c:pt idx="2">
                  <c:v>9.3938860257352932</c:v>
                </c:pt>
                <c:pt idx="3">
                  <c:v>8.0090533621323523</c:v>
                </c:pt>
                <c:pt idx="4">
                  <c:v>4.70001674630541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413056"/>
        <c:axId val="35166976"/>
      </c:barChart>
      <c:catAx>
        <c:axId val="2413056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b="0"/>
                </a:pPr>
                <a:r>
                  <a:rPr lang="en-US" b="0"/>
                  <a:t>EE concentration (</a:t>
                </a:r>
                <a:r>
                  <a:rPr lang="en-US" b="0">
                    <a:latin typeface="Times New Roman"/>
                    <a:cs typeface="Times New Roman"/>
                  </a:rPr>
                  <a:t>µ</a:t>
                </a:r>
                <a:r>
                  <a:rPr lang="en-US" b="0"/>
                  <a:t>M)</a:t>
                </a:r>
              </a:p>
            </c:rich>
          </c:tx>
          <c:layout/>
          <c:overlay val="0"/>
        </c:title>
        <c:majorTickMark val="out"/>
        <c:minorTickMark val="none"/>
        <c:tickLblPos val="nextTo"/>
        <c:crossAx val="35166976"/>
        <c:crosses val="autoZero"/>
        <c:auto val="1"/>
        <c:lblAlgn val="ctr"/>
        <c:lblOffset val="100"/>
        <c:noMultiLvlLbl val="0"/>
      </c:catAx>
      <c:valAx>
        <c:axId val="35166976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b="0"/>
                </a:pPr>
                <a:r>
                  <a:rPr lang="en-US" b="0"/>
                  <a:t>ATP nmol/mg of protein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2413056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/>
          <a:lstStyle/>
          <a:p>
            <a:pPr>
              <a:defRPr b="0"/>
            </a:pPr>
            <a:r>
              <a:rPr lang="en-US" b="0"/>
              <a:t>ATP content</a:t>
            </a:r>
          </a:p>
        </c:rich>
      </c:tx>
      <c:layout/>
      <c:overlay val="0"/>
    </c:title>
    <c:autoTitleDeleted val="0"/>
    <c:plotArea>
      <c:layout>
        <c:manualLayout>
          <c:layoutTarget val="inner"/>
          <c:xMode val="edge"/>
          <c:yMode val="edge"/>
          <c:x val="0.18702630872474832"/>
          <c:y val="0.20357061966238993"/>
          <c:w val="0.76931385298229193"/>
          <c:h val="0.48335531662603087"/>
        </c:manualLayout>
      </c:layout>
      <c:barChart>
        <c:barDir val="col"/>
        <c:grouping val="clustered"/>
        <c:varyColors val="0"/>
        <c:ser>
          <c:idx val="0"/>
          <c:order val="0"/>
          <c:tx>
            <c:v>ss</c:v>
          </c:tx>
          <c:invertIfNegative val="0"/>
          <c:errBars>
            <c:errBarType val="both"/>
            <c:errValType val="cust"/>
            <c:noEndCap val="0"/>
            <c:plus>
              <c:numRef>
                <c:f>'ATP fpr paper'!$N$99:$N$102</c:f>
                <c:numCache>
                  <c:formatCode>General</c:formatCode>
                  <c:ptCount val="4"/>
                  <c:pt idx="0">
                    <c:v>1.2337578490065164</c:v>
                  </c:pt>
                  <c:pt idx="1">
                    <c:v>1.3298388869878977</c:v>
                  </c:pt>
                  <c:pt idx="2">
                    <c:v>1.1487916751242593</c:v>
                  </c:pt>
                  <c:pt idx="3">
                    <c:v>0.90149457343391737</c:v>
                  </c:pt>
                </c:numCache>
              </c:numRef>
            </c:plus>
            <c:minus>
              <c:numRef>
                <c:f>'ATP fpr paper'!$N$99:$N$102</c:f>
                <c:numCache>
                  <c:formatCode>General</c:formatCode>
                  <c:ptCount val="4"/>
                  <c:pt idx="0">
                    <c:v>1.2337578490065164</c:v>
                  </c:pt>
                  <c:pt idx="1">
                    <c:v>1.3298388869878977</c:v>
                  </c:pt>
                  <c:pt idx="2">
                    <c:v>1.1487916751242593</c:v>
                  </c:pt>
                  <c:pt idx="3">
                    <c:v>0.90149457343391737</c:v>
                  </c:pt>
                </c:numCache>
              </c:numRef>
            </c:minus>
          </c:errBars>
          <c:cat>
            <c:strRef>
              <c:f>'ATP fpr paper'!$J$99:$J$102</c:f>
              <c:strCache>
                <c:ptCount val="4"/>
                <c:pt idx="0">
                  <c:v>control</c:v>
                </c:pt>
                <c:pt idx="1">
                  <c:v>0.3</c:v>
                </c:pt>
                <c:pt idx="2">
                  <c:v>1</c:v>
                </c:pt>
                <c:pt idx="3">
                  <c:v>3</c:v>
                </c:pt>
              </c:strCache>
            </c:strRef>
          </c:cat>
          <c:val>
            <c:numRef>
              <c:f>'ATP fpr paper'!$M$99:$M$102</c:f>
              <c:numCache>
                <c:formatCode>General</c:formatCode>
                <c:ptCount val="4"/>
                <c:pt idx="0">
                  <c:v>7.6027672000000006</c:v>
                </c:pt>
                <c:pt idx="1">
                  <c:v>6.8859111999999989</c:v>
                </c:pt>
                <c:pt idx="2">
                  <c:v>5.8783143999999998</c:v>
                </c:pt>
                <c:pt idx="3">
                  <c:v>2.497381599999999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414080"/>
        <c:axId val="35555008"/>
      </c:barChart>
      <c:catAx>
        <c:axId val="2414080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b="0"/>
                </a:pPr>
                <a:r>
                  <a:rPr lang="en-US" b="0"/>
                  <a:t>APAP concentration (mM)</a:t>
                </a:r>
              </a:p>
            </c:rich>
          </c:tx>
          <c:layout/>
          <c:overlay val="0"/>
        </c:title>
        <c:majorTickMark val="out"/>
        <c:minorTickMark val="none"/>
        <c:tickLblPos val="nextTo"/>
        <c:crossAx val="35555008"/>
        <c:crosses val="autoZero"/>
        <c:auto val="1"/>
        <c:lblAlgn val="ctr"/>
        <c:lblOffset val="100"/>
        <c:noMultiLvlLbl val="0"/>
      </c:catAx>
      <c:valAx>
        <c:axId val="35555008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b="0"/>
                </a:pPr>
                <a:r>
                  <a:rPr lang="en-US" b="0"/>
                  <a:t>ATP nmol/mg of protein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2414080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/>
          <a:lstStyle/>
          <a:p>
            <a:pPr>
              <a:defRPr b="0"/>
            </a:pPr>
            <a:r>
              <a:rPr lang="en-US" b="0"/>
              <a:t>ATP content</a:t>
            </a:r>
          </a:p>
        </c:rich>
      </c:tx>
      <c:layout/>
      <c:overlay val="0"/>
    </c:title>
    <c:autoTitleDeleted val="0"/>
    <c:plotArea>
      <c:layout>
        <c:manualLayout>
          <c:layoutTarget val="inner"/>
          <c:xMode val="edge"/>
          <c:yMode val="edge"/>
          <c:x val="0.20137122282791575"/>
          <c:y val="0.20357061966238993"/>
          <c:w val="0.7516202301635373"/>
          <c:h val="0.48335531662603087"/>
        </c:manualLayout>
      </c:layout>
      <c:barChart>
        <c:barDir val="col"/>
        <c:grouping val="clustered"/>
        <c:varyColors val="0"/>
        <c:ser>
          <c:idx val="0"/>
          <c:order val="0"/>
          <c:tx>
            <c:v>a</c:v>
          </c:tx>
          <c:invertIfNegative val="0"/>
          <c:errBars>
            <c:errBarType val="both"/>
            <c:errValType val="cust"/>
            <c:noEndCap val="0"/>
            <c:plus>
              <c:numRef>
                <c:f>'ATP fpr paper'!$N$105:$N$108</c:f>
                <c:numCache>
                  <c:formatCode>General</c:formatCode>
                  <c:ptCount val="4"/>
                  <c:pt idx="0">
                    <c:v>0.90959023895884761</c:v>
                  </c:pt>
                  <c:pt idx="1">
                    <c:v>1.2364287306184689</c:v>
                  </c:pt>
                  <c:pt idx="2">
                    <c:v>0.64677850696107697</c:v>
                  </c:pt>
                  <c:pt idx="3">
                    <c:v>1.654549644165805</c:v>
                  </c:pt>
                </c:numCache>
              </c:numRef>
            </c:plus>
            <c:minus>
              <c:numRef>
                <c:f>'ATP fpr paper'!$N$105:$N$108</c:f>
                <c:numCache>
                  <c:formatCode>General</c:formatCode>
                  <c:ptCount val="4"/>
                  <c:pt idx="0">
                    <c:v>0.90959023895884761</c:v>
                  </c:pt>
                  <c:pt idx="1">
                    <c:v>1.2364287306184689</c:v>
                  </c:pt>
                  <c:pt idx="2">
                    <c:v>0.64677850696107697</c:v>
                  </c:pt>
                  <c:pt idx="3">
                    <c:v>1.654549644165805</c:v>
                  </c:pt>
                </c:numCache>
              </c:numRef>
            </c:minus>
          </c:errBars>
          <c:cat>
            <c:strRef>
              <c:f>'ATP fpr paper'!$J$105:$J$108</c:f>
              <c:strCache>
                <c:ptCount val="4"/>
                <c:pt idx="0">
                  <c:v>control</c:v>
                </c:pt>
                <c:pt idx="1">
                  <c:v>0.1</c:v>
                </c:pt>
                <c:pt idx="2">
                  <c:v>0.5</c:v>
                </c:pt>
                <c:pt idx="3">
                  <c:v>1</c:v>
                </c:pt>
              </c:strCache>
            </c:strRef>
          </c:cat>
          <c:val>
            <c:numRef>
              <c:f>'ATP fpr paper'!$M$105:$M$108</c:f>
              <c:numCache>
                <c:formatCode>General</c:formatCode>
                <c:ptCount val="4"/>
                <c:pt idx="0">
                  <c:v>7.4119303999999993</c:v>
                </c:pt>
                <c:pt idx="1">
                  <c:v>7.1833831999999997</c:v>
                </c:pt>
                <c:pt idx="2">
                  <c:v>7.6079191999999995</c:v>
                </c:pt>
                <c:pt idx="3">
                  <c:v>7.503221599999999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414592"/>
        <c:axId val="35557312"/>
      </c:barChart>
      <c:catAx>
        <c:axId val="2414592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b="0"/>
                </a:pPr>
                <a:r>
                  <a:rPr lang="en-US" b="0"/>
                  <a:t>ISND concentration (mM)</a:t>
                </a:r>
              </a:p>
            </c:rich>
          </c:tx>
          <c:layout/>
          <c:overlay val="0"/>
        </c:title>
        <c:majorTickMark val="out"/>
        <c:minorTickMark val="none"/>
        <c:tickLblPos val="nextTo"/>
        <c:crossAx val="35557312"/>
        <c:crosses val="autoZero"/>
        <c:auto val="1"/>
        <c:lblAlgn val="ctr"/>
        <c:lblOffset val="100"/>
        <c:noMultiLvlLbl val="0"/>
      </c:catAx>
      <c:valAx>
        <c:axId val="35557312"/>
        <c:scaling>
          <c:orientation val="minMax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b="0"/>
                </a:pPr>
                <a:r>
                  <a:rPr lang="en-US" b="0"/>
                  <a:t>ATP nmol/mg of protein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2414592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/>
          <a:lstStyle/>
          <a:p>
            <a:pPr>
              <a:defRPr b="0"/>
            </a:pPr>
            <a:r>
              <a:rPr lang="en-US" b="0"/>
              <a:t>ATP content</a:t>
            </a:r>
          </a:p>
        </c:rich>
      </c:tx>
      <c:layout/>
      <c:overlay val="0"/>
    </c:title>
    <c:autoTitleDeleted val="0"/>
    <c:plotArea>
      <c:layout>
        <c:manualLayout>
          <c:layoutTarget val="inner"/>
          <c:xMode val="edge"/>
          <c:yMode val="edge"/>
          <c:x val="0.21815215806357538"/>
          <c:y val="0.20357061966238993"/>
          <c:w val="0.73092191601049872"/>
          <c:h val="0.48335531662603087"/>
        </c:manualLayout>
      </c:layout>
      <c:barChart>
        <c:barDir val="col"/>
        <c:grouping val="clustered"/>
        <c:varyColors val="0"/>
        <c:ser>
          <c:idx val="0"/>
          <c:order val="0"/>
          <c:tx>
            <c:v>s</c:v>
          </c:tx>
          <c:invertIfNegative val="0"/>
          <c:errBars>
            <c:errBarType val="both"/>
            <c:errValType val="cust"/>
            <c:noEndCap val="0"/>
            <c:plus>
              <c:numRef>
                <c:f>'ATP fpr paper'!$N$111:$N$114</c:f>
                <c:numCache>
                  <c:formatCode>General</c:formatCode>
                  <c:ptCount val="4"/>
                  <c:pt idx="0">
                    <c:v>1.3011940975745271</c:v>
                  </c:pt>
                  <c:pt idx="1">
                    <c:v>1.907141113794675</c:v>
                  </c:pt>
                  <c:pt idx="2">
                    <c:v>1.3329131875687927</c:v>
                  </c:pt>
                  <c:pt idx="3">
                    <c:v>1.5803244929604789</c:v>
                  </c:pt>
                </c:numCache>
              </c:numRef>
            </c:plus>
            <c:minus>
              <c:numRef>
                <c:f>'ATP fpr paper'!$N$111:$N$114</c:f>
                <c:numCache>
                  <c:formatCode>General</c:formatCode>
                  <c:ptCount val="4"/>
                  <c:pt idx="0">
                    <c:v>1.3011940975745271</c:v>
                  </c:pt>
                  <c:pt idx="1">
                    <c:v>1.907141113794675</c:v>
                  </c:pt>
                  <c:pt idx="2">
                    <c:v>1.3329131875687927</c:v>
                  </c:pt>
                  <c:pt idx="3">
                    <c:v>1.5803244929604789</c:v>
                  </c:pt>
                </c:numCache>
              </c:numRef>
            </c:minus>
          </c:errBars>
          <c:cat>
            <c:strRef>
              <c:f>'ATP fpr paper'!$J$111:$J$114</c:f>
              <c:strCache>
                <c:ptCount val="4"/>
                <c:pt idx="0">
                  <c:v>control</c:v>
                </c:pt>
                <c:pt idx="1">
                  <c:v>1</c:v>
                </c:pt>
                <c:pt idx="2">
                  <c:v>5</c:v>
                </c:pt>
                <c:pt idx="3">
                  <c:v>10</c:v>
                </c:pt>
              </c:strCache>
            </c:strRef>
          </c:cat>
          <c:val>
            <c:numRef>
              <c:f>'ATP fpr paper'!$M$111:$M$114</c:f>
              <c:numCache>
                <c:formatCode>General</c:formatCode>
                <c:ptCount val="4"/>
                <c:pt idx="0">
                  <c:v>7.0901768000000009</c:v>
                </c:pt>
                <c:pt idx="1">
                  <c:v>8.5402625000000008</c:v>
                </c:pt>
                <c:pt idx="2">
                  <c:v>6.5571127999999996</c:v>
                </c:pt>
                <c:pt idx="3">
                  <c:v>4.853195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415104"/>
        <c:axId val="35560192"/>
      </c:barChart>
      <c:catAx>
        <c:axId val="2415104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b="0"/>
                </a:pPr>
                <a:r>
                  <a:rPr lang="en-US" b="0"/>
                  <a:t>PQ concentration (</a:t>
                </a:r>
                <a:r>
                  <a:rPr lang="en-US" b="0">
                    <a:latin typeface="Times New Roman"/>
                    <a:cs typeface="Times New Roman"/>
                  </a:rPr>
                  <a:t>µ</a:t>
                </a:r>
                <a:r>
                  <a:rPr lang="en-US" b="0"/>
                  <a:t>M)</a:t>
                </a:r>
              </a:p>
            </c:rich>
          </c:tx>
          <c:layout/>
          <c:overlay val="0"/>
        </c:title>
        <c:majorTickMark val="out"/>
        <c:minorTickMark val="none"/>
        <c:tickLblPos val="nextTo"/>
        <c:crossAx val="35560192"/>
        <c:crosses val="autoZero"/>
        <c:auto val="1"/>
        <c:lblAlgn val="ctr"/>
        <c:lblOffset val="100"/>
        <c:noMultiLvlLbl val="0"/>
      </c:catAx>
      <c:valAx>
        <c:axId val="35560192"/>
        <c:scaling>
          <c:orientation val="minMax"/>
          <c:max val="1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b="0"/>
                </a:pPr>
                <a:r>
                  <a:rPr lang="en-US" b="0"/>
                  <a:t>ATP nmol/mg of protein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2415104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2335" cy="4659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064" y="0"/>
            <a:ext cx="2972335" cy="4659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C1CF9B8-702B-4647-8767-D79E2CF309D0}" type="datetimeFigureOut">
              <a:rPr lang="en-US" smtClean="0"/>
              <a:t>1/4/201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00138" y="698500"/>
            <a:ext cx="4657725" cy="34925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24681"/>
            <a:ext cx="5486400" cy="419094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46383"/>
            <a:ext cx="2972335" cy="46599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064" y="8846383"/>
            <a:ext cx="2972335" cy="46599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3DFD4C5-0EA2-4133-9F34-9F2EFBF58C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820102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F75EC8-F0D9-43A6-B39E-08880824E880}" type="datetimeFigureOut">
              <a:rPr lang="en-US" smtClean="0"/>
              <a:t>1/4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CEF102-51F4-4422-AEE8-AF6C5A24B5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33204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F75EC8-F0D9-43A6-B39E-08880824E880}" type="datetimeFigureOut">
              <a:rPr lang="en-US" smtClean="0"/>
              <a:t>1/4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CEF102-51F4-4422-AEE8-AF6C5A24B5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86318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F75EC8-F0D9-43A6-B39E-08880824E880}" type="datetimeFigureOut">
              <a:rPr lang="en-US" smtClean="0"/>
              <a:t>1/4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CEF102-51F4-4422-AEE8-AF6C5A24B5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92542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F75EC8-F0D9-43A6-B39E-08880824E880}" type="datetimeFigureOut">
              <a:rPr lang="en-US" smtClean="0"/>
              <a:t>1/4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CEF102-51F4-4422-AEE8-AF6C5A24B5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1335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F75EC8-F0D9-43A6-B39E-08880824E880}" type="datetimeFigureOut">
              <a:rPr lang="en-US" smtClean="0"/>
              <a:t>1/4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CEF102-51F4-4422-AEE8-AF6C5A24B5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73980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F75EC8-F0D9-43A6-B39E-08880824E880}" type="datetimeFigureOut">
              <a:rPr lang="en-US" smtClean="0"/>
              <a:t>1/4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CEF102-51F4-4422-AEE8-AF6C5A24B5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36250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F75EC8-F0D9-43A6-B39E-08880824E880}" type="datetimeFigureOut">
              <a:rPr lang="en-US" smtClean="0"/>
              <a:t>1/4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CEF102-51F4-4422-AEE8-AF6C5A24B5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27835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F75EC8-F0D9-43A6-B39E-08880824E880}" type="datetimeFigureOut">
              <a:rPr lang="en-US" smtClean="0"/>
              <a:t>1/4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CEF102-51F4-4422-AEE8-AF6C5A24B5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82699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F75EC8-F0D9-43A6-B39E-08880824E880}" type="datetimeFigureOut">
              <a:rPr lang="en-US" smtClean="0"/>
              <a:t>1/4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CEF102-51F4-4422-AEE8-AF6C5A24B5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96561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F75EC8-F0D9-43A6-B39E-08880824E880}" type="datetimeFigureOut">
              <a:rPr lang="en-US" smtClean="0"/>
              <a:t>1/4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CEF102-51F4-4422-AEE8-AF6C5A24B5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26419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F75EC8-F0D9-43A6-B39E-08880824E880}" type="datetimeFigureOut">
              <a:rPr lang="en-US" smtClean="0"/>
              <a:t>1/4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CEF102-51F4-4422-AEE8-AF6C5A24B5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21079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F75EC8-F0D9-43A6-B39E-08880824E880}" type="datetimeFigureOut">
              <a:rPr lang="en-US" smtClean="0"/>
              <a:t>1/4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CEF102-51F4-4422-AEE8-AF6C5A24B5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9377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42529801"/>
              </p:ext>
            </p:extLst>
          </p:nvPr>
        </p:nvGraphicFramePr>
        <p:xfrm>
          <a:off x="-152400" y="457200"/>
          <a:ext cx="3276600" cy="2133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Chart 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94317292"/>
              </p:ext>
            </p:extLst>
          </p:nvPr>
        </p:nvGraphicFramePr>
        <p:xfrm>
          <a:off x="2895600" y="457200"/>
          <a:ext cx="3276600" cy="2133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56561431"/>
              </p:ext>
            </p:extLst>
          </p:nvPr>
        </p:nvGraphicFramePr>
        <p:xfrm>
          <a:off x="5876014" y="457200"/>
          <a:ext cx="3276600" cy="2133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5" name="Chart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00856238"/>
              </p:ext>
            </p:extLst>
          </p:nvPr>
        </p:nvGraphicFramePr>
        <p:xfrm>
          <a:off x="663" y="3581400"/>
          <a:ext cx="3199737" cy="187642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6" name="Chart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22554549"/>
              </p:ext>
            </p:extLst>
          </p:nvPr>
        </p:nvGraphicFramePr>
        <p:xfrm>
          <a:off x="3048000" y="3581400"/>
          <a:ext cx="2971800" cy="187642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7" name="Chart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42414486"/>
              </p:ext>
            </p:extLst>
          </p:nvPr>
        </p:nvGraphicFramePr>
        <p:xfrm>
          <a:off x="6096000" y="3581400"/>
          <a:ext cx="2743200" cy="187642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</p:spTree>
    <p:extLst>
      <p:ext uri="{BB962C8B-B14F-4D97-AF65-F5344CB8AC3E}">
        <p14:creationId xmlns:p14="http://schemas.microsoft.com/office/powerpoint/2010/main" val="426998558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553</TotalTime>
  <Words>65</Words>
  <Application>Microsoft Office PowerPoint</Application>
  <PresentationFormat>On-screen Show (4:3)</PresentationFormat>
  <Paragraphs>18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wa Szalowska</dc:creator>
  <cp:lastModifiedBy>Ewa Szalowska</cp:lastModifiedBy>
  <cp:revision>122</cp:revision>
  <cp:lastPrinted>2013-08-03T11:48:09Z</cp:lastPrinted>
  <dcterms:created xsi:type="dcterms:W3CDTF">2013-04-04T11:53:58Z</dcterms:created>
  <dcterms:modified xsi:type="dcterms:W3CDTF">2014-01-04T20:33:44Z</dcterms:modified>
</cp:coreProperties>
</file>